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5" r:id="rId2"/>
    <p:sldId id="279" r:id="rId3"/>
    <p:sldId id="260" r:id="rId4"/>
    <p:sldId id="276" r:id="rId5"/>
    <p:sldId id="277" r:id="rId6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379D05B-2EC8-4D14-9C5B-8A320D5BEA17}" v="1" dt="2024-01-26T07:46:04.604"/>
    <p1510:client id="{C5B25F51-DDFD-4ECD-8A4B-5CA805F4A25B}" v="8" dt="2024-01-25T15:02:04.36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434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40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ilberger Hannes" userId="S::hannes.hilberger@fh-joanneum.at::37e7496a-df7b-427a-9635-ffbc14ee0120" providerId="AD" clId="Web-{C5B25F51-DDFD-4ECD-8A4B-5CA805F4A25B}"/>
    <pc:docChg chg="modSld">
      <pc:chgData name="Hilberger Hannes" userId="S::hannes.hilberger@fh-joanneum.at::37e7496a-df7b-427a-9635-ffbc14ee0120" providerId="AD" clId="Web-{C5B25F51-DDFD-4ECD-8A4B-5CA805F4A25B}" dt="2024-01-25T15:02:04.368" v="10" actId="20577"/>
      <pc:docMkLst>
        <pc:docMk/>
      </pc:docMkLst>
      <pc:sldChg chg="modSp">
        <pc:chgData name="Hilberger Hannes" userId="S::hannes.hilberger@fh-joanneum.at::37e7496a-df7b-427a-9635-ffbc14ee0120" providerId="AD" clId="Web-{C5B25F51-DDFD-4ECD-8A4B-5CA805F4A25B}" dt="2024-01-25T15:02:04.368" v="10" actId="20577"/>
        <pc:sldMkLst>
          <pc:docMk/>
          <pc:sldMk cId="1497047942" sldId="275"/>
        </pc:sldMkLst>
        <pc:spChg chg="mod">
          <ac:chgData name="Hilberger Hannes" userId="S::hannes.hilberger@fh-joanneum.at::37e7496a-df7b-427a-9635-ffbc14ee0120" providerId="AD" clId="Web-{C5B25F51-DDFD-4ECD-8A4B-5CA805F4A25B}" dt="2024-01-25T15:02:04.368" v="10" actId="20577"/>
          <ac:spMkLst>
            <pc:docMk/>
            <pc:sldMk cId="1497047942" sldId="275"/>
            <ac:spMk id="3" creationId="{73D64289-25EA-0152-12B6-5E4834CFC8E3}"/>
          </ac:spMkLst>
        </pc:spChg>
      </pc:sldChg>
    </pc:docChg>
  </pc:docChgLst>
  <pc:docChgLst>
    <pc:chgData name="Hilberger Hannes" userId="S::hannes.hilberger@fh-joanneum.at::37e7496a-df7b-427a-9635-ffbc14ee0120" providerId="AD" clId="Web-{4379D05B-2EC8-4D14-9C5B-8A320D5BEA17}"/>
    <pc:docChg chg="delSld">
      <pc:chgData name="Hilberger Hannes" userId="S::hannes.hilberger@fh-joanneum.at::37e7496a-df7b-427a-9635-ffbc14ee0120" providerId="AD" clId="Web-{4379D05B-2EC8-4D14-9C5B-8A320D5BEA17}" dt="2024-01-26T07:46:04.604" v="0"/>
      <pc:docMkLst>
        <pc:docMk/>
      </pc:docMkLst>
      <pc:sldChg chg="del">
        <pc:chgData name="Hilberger Hannes" userId="S::hannes.hilberger@fh-joanneum.at::37e7496a-df7b-427a-9635-ffbc14ee0120" providerId="AD" clId="Web-{4379D05B-2EC8-4D14-9C5B-8A320D5BEA17}" dt="2024-01-26T07:46:04.604" v="0"/>
        <pc:sldMkLst>
          <pc:docMk/>
          <pc:sldMk cId="1482315558" sldId="278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bg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BE1ADA1-B8C1-E0C3-4F0D-2523269CE5D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de-AT"/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EEBBDACA-CED7-868D-2CDF-DACE4591E4F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de-AT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E742410-CBF4-D7F8-4EBB-F163F86AD3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0145F-D6DF-4C1B-A8B8-A4A66ABA44E7}" type="datetimeFigureOut">
              <a:rPr lang="de-AT" smtClean="0"/>
              <a:t>22.06.2025</a:t>
            </a:fld>
            <a:endParaRPr lang="de-AT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BC49C3B-989C-91D6-6B78-4780081DAF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5108FAF-9437-8EA8-EF52-0EBB666BFB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E95CB-829D-4B04-8227-80DBE92853DA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1053803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2119074-77EC-D9D1-61B7-A2B434348E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AT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BBAD9747-3462-7439-D32D-CE14EC9DA6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D474F2B-94F4-1FA1-938D-8647BDD04B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0145F-D6DF-4C1B-A8B8-A4A66ABA44E7}" type="datetimeFigureOut">
              <a:rPr lang="de-AT" smtClean="0"/>
              <a:t>22.06.2025</a:t>
            </a:fld>
            <a:endParaRPr lang="de-AT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CC510F9-FF9C-2386-338E-4943A68ABD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0A5D47B-C8FB-F2C5-B971-365C2FB70D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E95CB-829D-4B04-8227-80DBE92853DA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4447036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298AA999-C80F-2751-FBC8-010549EE586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de-AT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0C5D580C-17C8-CC78-29DA-C7FB52F6A1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912032F-98D6-8C2A-50BE-0FBDBF3E3F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0145F-D6DF-4C1B-A8B8-A4A66ABA44E7}" type="datetimeFigureOut">
              <a:rPr lang="de-AT" smtClean="0"/>
              <a:t>22.06.2025</a:t>
            </a:fld>
            <a:endParaRPr lang="de-AT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4DB08FF-64A3-07A7-0420-F9D2049098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9B30313-F5E4-4813-C06F-CEF788CF22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E95CB-829D-4B04-8227-80DBE92853DA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787999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bg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C31AA01-B412-0B2C-8CE0-7DE6110CA6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AT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E8FFC902-EEE1-1F63-3535-E874C13D61C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38700CA-9EAE-20BC-D552-DCB7869ECC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0145F-D6DF-4C1B-A8B8-A4A66ABA44E7}" type="datetimeFigureOut">
              <a:rPr lang="de-AT" smtClean="0"/>
              <a:t>22.06.2025</a:t>
            </a:fld>
            <a:endParaRPr lang="de-AT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AB5F5D3-9B4C-2CC8-C515-0F8C38DDF4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F436311-26E8-606C-7A25-0C8AA98F84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E95CB-829D-4B04-8227-80DBE92853DA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9661768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002D240-8528-B5B0-CAEA-A5012E7ABA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de-AT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FD21040-F448-EBF7-C27C-8D7DE000CA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A9DD09B-EF93-FD02-97B9-98BD225A5F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0145F-D6DF-4C1B-A8B8-A4A66ABA44E7}" type="datetimeFigureOut">
              <a:rPr lang="de-AT" smtClean="0"/>
              <a:t>22.06.2025</a:t>
            </a:fld>
            <a:endParaRPr lang="de-AT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12D4229-BF0B-1BA5-0EDC-E1F73E1C90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2EE9138-011B-D00F-D886-810DA87AE7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E95CB-829D-4B04-8227-80DBE92853DA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9601473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1A05A71-FF37-F0F9-6EF2-D49FD248C3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AT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1D0D7DD5-4DA9-6C5C-BE14-AF4D39141B9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C52D2077-5F95-E203-553F-B4CE6F9C5D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BFDD9CEE-6ABD-F782-C140-40D78885F4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0145F-D6DF-4C1B-A8B8-A4A66ABA44E7}" type="datetimeFigureOut">
              <a:rPr lang="de-AT" smtClean="0"/>
              <a:t>22.06.2025</a:t>
            </a:fld>
            <a:endParaRPr lang="de-AT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96595812-9911-0253-DF24-10C0928DDD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D24430A-9F09-EACA-6271-892162DE5F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E95CB-829D-4B04-8227-80DBE92853DA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3570891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173098E-F521-E172-448A-C5D311A08C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de-AT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84D6BAA7-3E31-822E-D030-CE175DA36E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F53461BF-A9D7-53CB-527A-B78ED8119F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2F53CA1C-965D-D0DC-B40A-370603EBD8C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76D906C9-FF81-2C12-170B-4B0F3B4B149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BB32DDC5-81B2-C354-D0D4-BD0A369DAE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0145F-D6DF-4C1B-A8B8-A4A66ABA44E7}" type="datetimeFigureOut">
              <a:rPr lang="de-AT" smtClean="0"/>
              <a:t>22.06.2025</a:t>
            </a:fld>
            <a:endParaRPr lang="de-AT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2F9671AD-1E4F-0128-764C-2983E13C45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D8F1AFAA-842B-A0FF-5040-8F255041F0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E95CB-829D-4B04-8227-80DBE92853DA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0491417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733E7BB-6DDC-C85E-F7B8-036149504A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AT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CD50321E-9F63-7096-32C5-F4EBEF0812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0145F-D6DF-4C1B-A8B8-A4A66ABA44E7}" type="datetimeFigureOut">
              <a:rPr lang="de-AT" smtClean="0"/>
              <a:t>22.06.2025</a:t>
            </a:fld>
            <a:endParaRPr lang="de-AT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9F8F9883-538F-5AD9-E670-5FB076DA69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BE2FD200-6823-5447-29AA-24F7D37071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E95CB-829D-4B04-8227-80DBE92853DA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3999487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96F79584-7886-69FC-A482-955E3D5B6B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0145F-D6DF-4C1B-A8B8-A4A66ABA44E7}" type="datetimeFigureOut">
              <a:rPr lang="de-AT" smtClean="0"/>
              <a:t>22.06.2025</a:t>
            </a:fld>
            <a:endParaRPr lang="de-AT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51D338E6-CF23-2F3D-359F-6DBE69C0B4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1E408015-FDC0-3202-6889-E5A0CED798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E95CB-829D-4B04-8227-80DBE92853DA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5762954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118104B-9573-37B3-2E4B-7FC77CAD41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de-AT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CF8E685A-45C9-CC7E-EA98-73F29836C6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3DDC9A2E-4FF0-75BC-8E33-9554059845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D444AF26-89E5-AC1D-02BE-41DD4192AB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0145F-D6DF-4C1B-A8B8-A4A66ABA44E7}" type="datetimeFigureOut">
              <a:rPr lang="de-AT" smtClean="0"/>
              <a:t>22.06.2025</a:t>
            </a:fld>
            <a:endParaRPr lang="de-AT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D051A9F-93EC-AF88-E360-4D0D70AE68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10955605-6CC4-9E04-3B5A-F77635E828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E95CB-829D-4B04-8227-80DBE92853DA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9542892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3BD55B0-F927-00D8-D45D-AB1AA6EE38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de-AT"/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DA594449-C0BF-9877-5E8D-2C1ED03BE93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AT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BD6371E7-A2C8-A24A-3E7D-E2185374D7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82108A21-A72F-6A59-06F0-2F56D1BF33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0145F-D6DF-4C1B-A8B8-A4A66ABA44E7}" type="datetimeFigureOut">
              <a:rPr lang="de-AT" smtClean="0"/>
              <a:t>22.06.2025</a:t>
            </a:fld>
            <a:endParaRPr lang="de-AT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3C3F2266-C588-1E90-6F2F-E53F1C5719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7AE55644-1867-4855-FF51-0748217047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E95CB-829D-4B04-8227-80DBE92853DA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9573513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2FAABB29-075C-F1DA-FE0D-AFC27890EA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de-AT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DC45EF0-C7A3-B657-080C-81E915B631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4DA9204-2991-3F58-B0D8-A12DFD1972E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030145F-D6DF-4C1B-A8B8-A4A66ABA44E7}" type="datetimeFigureOut">
              <a:rPr lang="de-AT" smtClean="0"/>
              <a:t>22.06.2025</a:t>
            </a:fld>
            <a:endParaRPr lang="de-AT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1BFB3AF-E194-FA23-71E9-7707A3DC0FB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B222809-5911-19CB-2244-7292A747B7B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F5E95CB-829D-4B04-8227-80DBE92853DA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1126919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://dx.doi.org/10.2196/jmir.xxxx" TargetMode="External"/><Relationship Id="rId2" Type="http://schemas.openxmlformats.org/officeDocument/2006/relationships/hyperlink" Target="http://dx.doi.org/10.2196/jmir.66660" TargetMode="Externa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79AF169-68F9-78C8-88D1-EB586679F4E4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de-DE">
                <a:solidFill>
                  <a:schemeClr val="bg1"/>
                </a:solidFill>
              </a:rPr>
              <a:t>LETHE CTMS </a:t>
            </a:r>
            <a:r>
              <a:rPr lang="de-DE" dirty="0">
                <a:solidFill>
                  <a:schemeClr val="bg1"/>
                </a:solidFill>
              </a:rPr>
              <a:t>Screenshots</a:t>
            </a:r>
            <a:endParaRPr lang="de-AT" dirty="0">
              <a:solidFill>
                <a:schemeClr val="bg1"/>
              </a:solidFill>
            </a:endParaRP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73D64289-25EA-0152-12B6-5E4834CFC8E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3250100"/>
          </a:xfrm>
        </p:spPr>
        <p:txBody>
          <a:bodyPr vert="horz" lIns="91440" tIns="45720" rIns="91440" bIns="45720" rtlCol="0" anchor="t">
            <a:normAutofit lnSpcReduction="10000"/>
          </a:bodyPr>
          <a:lstStyle/>
          <a:p>
            <a:r>
              <a:rPr lang="en-US" dirty="0">
                <a:solidFill>
                  <a:schemeClr val="bg1"/>
                </a:solidFill>
              </a:rPr>
              <a:t>This is a Multimedia Appendix to a full manuscript published in the J Med Internet Res. For full copyright and citation information see </a:t>
            </a:r>
            <a:r>
              <a:rPr lang="en-US" dirty="0">
                <a:solidFill>
                  <a:schemeClr val="bg1"/>
                </a:solidFill>
                <a:hlinkClick r:id="rId2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://dx.doi.org/10.2196/jmir.66660</a:t>
            </a:r>
            <a:endParaRPr lang="de-AT" dirty="0">
              <a:solidFill>
                <a:schemeClr val="bg1"/>
              </a:solidFill>
              <a:hlinkClick r:id="rId3"/>
            </a:endParaRPr>
          </a:p>
          <a:p>
            <a:endParaRPr lang="en-US" dirty="0">
              <a:solidFill>
                <a:schemeClr val="bg1"/>
              </a:solidFill>
            </a:endParaRPr>
          </a:p>
          <a:p>
            <a:endParaRPr lang="en-US" dirty="0">
              <a:solidFill>
                <a:schemeClr val="bg1"/>
              </a:solidFill>
            </a:endParaRPr>
          </a:p>
          <a:p>
            <a:endParaRPr lang="en-US" dirty="0">
              <a:solidFill>
                <a:schemeClr val="bg1"/>
              </a:solidFill>
            </a:endParaRPr>
          </a:p>
          <a:p>
            <a:pPr>
              <a:lnSpc>
                <a:spcPct val="80000"/>
              </a:lnSpc>
            </a:pPr>
            <a:endParaRPr lang="en-US" dirty="0">
              <a:solidFill>
                <a:schemeClr val="bg1"/>
              </a:solidFill>
              <a:latin typeface="Aptos" panose="02110004020202020204"/>
              <a:cs typeface="Segoe UI"/>
            </a:endParaRPr>
          </a:p>
          <a:p>
            <a:r>
              <a:rPr lang="en-US" sz="1400" dirty="0">
                <a:solidFill>
                  <a:schemeClr val="bg1"/>
                </a:solidFill>
                <a:latin typeface="Aptos"/>
                <a:cs typeface="Segoe UI"/>
              </a:rPr>
              <a:t>The LETHE project has received funding from the European Union’s Horizon 2020 research and innovation </a:t>
            </a:r>
            <a:r>
              <a:rPr lang="en-US" sz="1400" dirty="0" err="1">
                <a:solidFill>
                  <a:schemeClr val="bg1"/>
                </a:solidFill>
                <a:latin typeface="Aptos"/>
                <a:cs typeface="Segoe UI"/>
              </a:rPr>
              <a:t>programme</a:t>
            </a:r>
            <a:r>
              <a:rPr lang="en-US" sz="1400" dirty="0">
                <a:solidFill>
                  <a:schemeClr val="bg1"/>
                </a:solidFill>
                <a:latin typeface="Aptos"/>
                <a:cs typeface="Segoe UI"/>
              </a:rPr>
              <a:t> under grant agreement no 101017405.</a:t>
            </a:r>
            <a:endParaRPr lang="en-US" sz="14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970479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92393D6-05F9-91E5-B8A5-A50ED2FF7D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de-DE" sz="4000" dirty="0">
                <a:solidFill>
                  <a:schemeClr val="bg1"/>
                </a:solidFill>
              </a:rPr>
              <a:t>Login</a:t>
            </a:r>
            <a:endParaRPr lang="de-AT" sz="4000" dirty="0">
              <a:solidFill>
                <a:schemeClr val="bg1"/>
              </a:solidFill>
            </a:endParaRPr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25455019-6F87-EBE4-6649-919EB3B458B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43200" y="1328738"/>
            <a:ext cx="9305600" cy="5234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654195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92393D6-05F9-91E5-B8A5-A50ED2FF7D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de-DE" sz="4000" dirty="0" err="1">
                <a:solidFill>
                  <a:schemeClr val="bg1"/>
                </a:solidFill>
              </a:rPr>
              <a:t>Overview</a:t>
            </a:r>
            <a:r>
              <a:rPr lang="de-DE" sz="4000" dirty="0">
                <a:solidFill>
                  <a:schemeClr val="bg1"/>
                </a:solidFill>
              </a:rPr>
              <a:t> </a:t>
            </a:r>
            <a:r>
              <a:rPr lang="de-DE" sz="4000" dirty="0" err="1">
                <a:solidFill>
                  <a:schemeClr val="bg1"/>
                </a:solidFill>
              </a:rPr>
              <a:t>of</a:t>
            </a:r>
            <a:r>
              <a:rPr lang="de-DE" sz="4000" dirty="0">
                <a:solidFill>
                  <a:schemeClr val="bg1"/>
                </a:solidFill>
              </a:rPr>
              <a:t> all </a:t>
            </a:r>
            <a:r>
              <a:rPr lang="de-DE" sz="4000" dirty="0" err="1">
                <a:solidFill>
                  <a:schemeClr val="bg1"/>
                </a:solidFill>
              </a:rPr>
              <a:t>participants</a:t>
            </a:r>
            <a:endParaRPr lang="de-AT" sz="4000" dirty="0">
              <a:solidFill>
                <a:schemeClr val="bg1"/>
              </a:solidFill>
            </a:endParaRPr>
          </a:p>
        </p:txBody>
      </p:sp>
      <p:pic>
        <p:nvPicPr>
          <p:cNvPr id="3" name="Picture 45" descr="Ein Bild, das Text, Screenshot, Software, Computersymbol enthält.&#10;&#10;Automatisch generierte Beschreibung">
            <a:extLst>
              <a:ext uri="{FF2B5EF4-FFF2-40B4-BE49-F238E27FC236}">
                <a16:creationId xmlns:a16="http://schemas.microsoft.com/office/drawing/2014/main" id="{781B6848-8189-1FCE-29DC-A11AC55A0BF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43566" y="1411416"/>
            <a:ext cx="9304867" cy="52338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53961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92393D6-05F9-91E5-B8A5-A50ED2FF7D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de-DE" sz="4000" dirty="0">
                <a:solidFill>
                  <a:schemeClr val="bg1"/>
                </a:solidFill>
              </a:rPr>
              <a:t>Detail </a:t>
            </a:r>
            <a:r>
              <a:rPr lang="de-DE" sz="4000" dirty="0" err="1">
                <a:solidFill>
                  <a:schemeClr val="bg1"/>
                </a:solidFill>
              </a:rPr>
              <a:t>view</a:t>
            </a:r>
            <a:r>
              <a:rPr lang="de-DE" sz="4000" dirty="0">
                <a:solidFill>
                  <a:schemeClr val="bg1"/>
                </a:solidFill>
              </a:rPr>
              <a:t> </a:t>
            </a:r>
            <a:r>
              <a:rPr lang="de-DE" sz="4000" dirty="0" err="1">
                <a:solidFill>
                  <a:schemeClr val="bg1"/>
                </a:solidFill>
              </a:rPr>
              <a:t>of</a:t>
            </a:r>
            <a:r>
              <a:rPr lang="de-DE" sz="4000" dirty="0">
                <a:solidFill>
                  <a:schemeClr val="bg1"/>
                </a:solidFill>
              </a:rPr>
              <a:t> a </a:t>
            </a:r>
            <a:r>
              <a:rPr lang="de-DE" sz="4000" dirty="0" err="1">
                <a:solidFill>
                  <a:schemeClr val="bg1"/>
                </a:solidFill>
              </a:rPr>
              <a:t>participant</a:t>
            </a:r>
            <a:endParaRPr lang="de-AT" sz="4000" dirty="0">
              <a:solidFill>
                <a:schemeClr val="bg1"/>
              </a:solidFill>
            </a:endParaRPr>
          </a:p>
        </p:txBody>
      </p:sp>
      <p:pic>
        <p:nvPicPr>
          <p:cNvPr id="4" name="Picture 46" descr="Ein Bild, das Text, Screenshot, Zahl, Software enthält.&#10;&#10;Automatisch generierte Beschreibung">
            <a:extLst>
              <a:ext uri="{FF2B5EF4-FFF2-40B4-BE49-F238E27FC236}">
                <a16:creationId xmlns:a16="http://schemas.microsoft.com/office/drawing/2014/main" id="{C5F3CA61-6592-5F00-70F4-128CB05057B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91156" y="1428750"/>
            <a:ext cx="9209687" cy="5234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10164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92393D6-05F9-91E5-B8A5-A50ED2FF7D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de-DE" sz="4000" dirty="0">
                <a:solidFill>
                  <a:schemeClr val="bg1"/>
                </a:solidFill>
              </a:rPr>
              <a:t>Electronic Case Report Form (</a:t>
            </a:r>
            <a:r>
              <a:rPr lang="de-DE" sz="4000" dirty="0" err="1">
                <a:solidFill>
                  <a:schemeClr val="bg1"/>
                </a:solidFill>
              </a:rPr>
              <a:t>eCRF</a:t>
            </a:r>
            <a:r>
              <a:rPr lang="de-DE" sz="4000" dirty="0">
                <a:solidFill>
                  <a:schemeClr val="bg1"/>
                </a:solidFill>
              </a:rPr>
              <a:t>)</a:t>
            </a:r>
            <a:endParaRPr lang="de-AT" sz="4000" dirty="0">
              <a:solidFill>
                <a:schemeClr val="bg1"/>
              </a:solidFill>
            </a:endParaRPr>
          </a:p>
        </p:txBody>
      </p:sp>
      <p:pic>
        <p:nvPicPr>
          <p:cNvPr id="3" name="Picture 343829349" descr="Ein Bild, das Text, Screenshot, Software, Webseite enthält.&#10;&#10;Automatisch generierte Beschreibung">
            <a:extLst>
              <a:ext uri="{FF2B5EF4-FFF2-40B4-BE49-F238E27FC236}">
                <a16:creationId xmlns:a16="http://schemas.microsoft.com/office/drawing/2014/main" id="{19F69FC6-D83B-AFC8-FD8D-B16C3F71997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200" y="1449705"/>
            <a:ext cx="10513061" cy="5234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80629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9</Words>
  <Application>Microsoft Office PowerPoint</Application>
  <PresentationFormat>Widescreen</PresentationFormat>
  <Paragraphs>11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ptos</vt:lpstr>
      <vt:lpstr>Aptos Display</vt:lpstr>
      <vt:lpstr>Arial</vt:lpstr>
      <vt:lpstr>Office</vt:lpstr>
      <vt:lpstr>LETHE CTMS Screenshots</vt:lpstr>
      <vt:lpstr>Login</vt:lpstr>
      <vt:lpstr>Overview of all participants</vt:lpstr>
      <vt:lpstr>Detail view of a participant</vt:lpstr>
      <vt:lpstr>Electronic Case Report Form (eCRF)</vt:lpstr>
    </vt:vector>
  </TitlesOfParts>
  <Company>FH JOANNEUM Gesellschaft mb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Login</dc:title>
  <dc:creator>Hilberger Hannes</dc:creator>
  <cp:lastModifiedBy>Hilberger Hannes</cp:lastModifiedBy>
  <cp:revision>14</cp:revision>
  <dcterms:created xsi:type="dcterms:W3CDTF">2024-01-22T14:25:22Z</dcterms:created>
  <dcterms:modified xsi:type="dcterms:W3CDTF">2025-06-22T08:48:45Z</dcterms:modified>
</cp:coreProperties>
</file>